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-1554" y="-7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65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808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846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515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512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015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773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17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536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021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696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78B7F-F40D-444B-9578-267EE203FDF9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3873F-9A06-45EB-826C-E4288AD624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982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e 17"/>
          <p:cNvGrpSpPr/>
          <p:nvPr/>
        </p:nvGrpSpPr>
        <p:grpSpPr>
          <a:xfrm>
            <a:off x="2195575" y="1373228"/>
            <a:ext cx="5730875" cy="3872815"/>
            <a:chOff x="2195575" y="1373228"/>
            <a:chExt cx="5730875" cy="3872815"/>
          </a:xfrm>
        </p:grpSpPr>
        <p:sp>
          <p:nvSpPr>
            <p:cNvPr id="4" name="Rectangle 3"/>
            <p:cNvSpPr/>
            <p:nvPr/>
          </p:nvSpPr>
          <p:spPr>
            <a:xfrm>
              <a:off x="2226007" y="3861048"/>
              <a:ext cx="5670010" cy="138499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2.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sz="12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sz="12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duction by </a:t>
              </a:r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bovis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nockout mutants under axenic conditions.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bovi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nockout mutants are described in Table 2. Mycoplasmas were grown under axenic conditions in DMEM-based medium with pyruvate (DMEM with pyruvate) or without pyruvate (DMEM w/o pyruvate). Calf thymus DNA (10 µg/mL) was added in each condition. For cell culture conditions, EBL cells (10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) were inoculated at an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I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2. H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duction was determined at 72 h. Data are the means of at least three independent assays. Standard deviations are indicated by error bars.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5575" y="1373228"/>
              <a:ext cx="5730875" cy="20843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7002276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0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Ecole Nationale Vétérinaire de Toulous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 Baranowski</dc:creator>
  <cp:lastModifiedBy>Eric Baranowski</cp:lastModifiedBy>
  <cp:revision>1</cp:revision>
  <dcterms:created xsi:type="dcterms:W3CDTF">2019-08-12T15:12:49Z</dcterms:created>
  <dcterms:modified xsi:type="dcterms:W3CDTF">2019-08-12T15:14:28Z</dcterms:modified>
</cp:coreProperties>
</file>